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9"/>
  </p:notesMasterIdLst>
  <p:sldIdLst>
    <p:sldId id="391" r:id="rId2"/>
    <p:sldId id="390" r:id="rId3"/>
    <p:sldId id="378" r:id="rId4"/>
    <p:sldId id="392" r:id="rId5"/>
    <p:sldId id="377" r:id="rId6"/>
    <p:sldId id="393" r:id="rId7"/>
    <p:sldId id="394" r:id="rId8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  <p15:guide id="3" orient="horz" pos="3800">
          <p15:clr>
            <a:srgbClr val="A4A3A4"/>
          </p15:clr>
        </p15:guide>
        <p15:guide id="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Bestbebase Basebebest" initials="BB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66CCFF"/>
    <a:srgbClr val="FF9933"/>
    <a:srgbClr val="FF0000"/>
    <a:srgbClr val="FFCC00"/>
    <a:srgbClr val="FF0066"/>
    <a:srgbClr val="FF3399"/>
    <a:srgbClr val="FF9900"/>
    <a:srgbClr val="FF7C80"/>
    <a:srgbClr val="99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510" autoAdjust="0"/>
    <p:restoredTop sz="95020" autoAdjust="0"/>
  </p:normalViewPr>
  <p:slideViewPr>
    <p:cSldViewPr showGuides="1">
      <p:cViewPr>
        <p:scale>
          <a:sx n="150" d="100"/>
          <a:sy n="150" d="100"/>
        </p:scale>
        <p:origin x="547" y="-2846"/>
      </p:cViewPr>
      <p:guideLst>
        <p:guide orient="horz" pos="3120"/>
        <p:guide pos="2160"/>
        <p:guide orient="horz" pos="3800"/>
        <p:guide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3"/>
          </a:xfrm>
          <a:prstGeom prst="rect">
            <a:avLst/>
          </a:prstGeom>
        </p:spPr>
        <p:txBody>
          <a:bodyPr vert="horz" lIns="92318" tIns="46158" rIns="92318" bIns="46158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4" y="0"/>
            <a:ext cx="2945659" cy="496333"/>
          </a:xfrm>
          <a:prstGeom prst="rect">
            <a:avLst/>
          </a:prstGeom>
        </p:spPr>
        <p:txBody>
          <a:bodyPr vert="horz" lIns="92318" tIns="46158" rIns="92318" bIns="46158" rtlCol="0"/>
          <a:lstStyle>
            <a:lvl1pPr algn="r">
              <a:defRPr sz="1200"/>
            </a:lvl1pPr>
          </a:lstStyle>
          <a:p>
            <a:fld id="{E824B075-993E-456A-9AAD-74A153754606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09788" y="742950"/>
            <a:ext cx="25781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318" tIns="46158" rIns="92318" bIns="4615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9" y="4715155"/>
            <a:ext cx="5438140" cy="4466988"/>
          </a:xfrm>
          <a:prstGeom prst="rect">
            <a:avLst/>
          </a:prstGeom>
        </p:spPr>
        <p:txBody>
          <a:bodyPr vert="horz" lIns="92318" tIns="46158" rIns="92318" bIns="4615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3"/>
          </a:xfrm>
          <a:prstGeom prst="rect">
            <a:avLst/>
          </a:prstGeom>
        </p:spPr>
        <p:txBody>
          <a:bodyPr vert="horz" lIns="92318" tIns="46158" rIns="92318" bIns="46158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4" y="9428583"/>
            <a:ext cx="2945659" cy="496333"/>
          </a:xfrm>
          <a:prstGeom prst="rect">
            <a:avLst/>
          </a:prstGeom>
        </p:spPr>
        <p:txBody>
          <a:bodyPr vert="horz" lIns="92318" tIns="46158" rIns="92318" bIns="46158" rtlCol="0" anchor="b"/>
          <a:lstStyle>
            <a:lvl1pPr algn="r">
              <a:defRPr sz="1200"/>
            </a:lvl1pPr>
          </a:lstStyle>
          <a:p>
            <a:fld id="{84E4320A-389F-4E82-B666-C1210CE4D3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228448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75908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129701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697"/>
            <a:ext cx="1157288" cy="1126807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6" y="529697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75537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3931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4051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6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1" y="3081867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1129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0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0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247006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6382173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116448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72849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2804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D0A503-1DD9-4F27-BF5A-D6E95D553D91}" type="datetimeFigureOut">
              <a:rPr kumimoji="1" lang="ja-JP" altLang="en-US" smtClean="0"/>
              <a:t>2025/12/1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C09CC-7A03-4D58-A11D-A0C6713363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26718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8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64D7D0-3817-AED0-FA6A-A7D0A1E450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42900" y="1280592"/>
            <a:ext cx="6326460" cy="5688632"/>
          </a:xfrm>
        </p:spPr>
        <p:txBody>
          <a:bodyPr>
            <a:normAutofit/>
          </a:bodyPr>
          <a:lstStyle/>
          <a:p>
            <a:pPr algn="l">
              <a:lnSpc>
                <a:spcPct val="150000"/>
              </a:lnSpc>
              <a:spcAft>
                <a:spcPts val="800"/>
              </a:spcAft>
              <a:buNone/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rgeting the Undruggable Transcription Factor, KLF5, with a Peptidomimetic Small Molecule, NC114, Attenuates Pressure Overload-Induced Cardiac Remodeling and Fibrosis</a:t>
            </a: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hanachai Methatham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200" kern="1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tsuka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Kimura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Shota Tomida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Tamaki Ishima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i Taguchi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,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Hideki Uosaki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Eiji Sakashita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Hitoshi Endo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Ryozo Nagai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,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r>
              <a:rPr lang="en-US" altLang="ja-JP" sz="1200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&amp; Kenichi Aizawa</a:t>
            </a:r>
            <a:r>
              <a:rPr lang="en-US" altLang="ja-JP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,4,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</a:t>
            </a: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epartment of Translational Research, Clinical Research Center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ichi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dical University Hospital, Tochigi, 329-0498, Japan</a:t>
            </a: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Division of Functional Biochemistry, Department of Biochemistry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ichi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dical University, Tochigi, 329-0498, Japan</a:t>
            </a:r>
            <a:b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ichi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dical University, Tochigi, 329-0498, Japan</a:t>
            </a: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i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Clinical Pharmacology Center, </a:t>
            </a:r>
            <a:r>
              <a:rPr lang="en-US" altLang="ja-JP" sz="12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Jichi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Medical University Hospital</a:t>
            </a:r>
            <a:r>
              <a:rPr lang="en-US" altLang="ja-JP" sz="1200" i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Tochigi, 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29-0498, Japan</a:t>
            </a:r>
            <a:br>
              <a:rPr lang="ja-JP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		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C40F84E-1FC3-D8AE-CBD3-6AF22ABBD3DB}"/>
              </a:ext>
            </a:extLst>
          </p:cNvPr>
          <p:cNvSpPr txBox="1"/>
          <p:nvPr/>
        </p:nvSpPr>
        <p:spPr>
          <a:xfrm>
            <a:off x="2060848" y="704528"/>
            <a:ext cx="34290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600" b="1" i="0" dirty="0">
                <a:solidFill>
                  <a:srgbClr val="1A1A1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en-US" altLang="ja-JP" sz="16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r>
              <a:rPr lang="en-US" altLang="ja-JP" sz="1600" b="1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able</a:t>
            </a:r>
            <a:r>
              <a:rPr lang="en-US" altLang="ja-JP" sz="16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 for</a:t>
            </a:r>
            <a:br>
              <a:rPr lang="en-US" altLang="ja-JP" sz="16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endParaRPr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583213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6F804D6-7872-BDFF-6028-7AB480CF720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Content Placeholder 2">
            <a:extLst>
              <a:ext uri="{FF2B5EF4-FFF2-40B4-BE49-F238E27FC236}">
                <a16:creationId xmlns:a16="http://schemas.microsoft.com/office/drawing/2014/main" id="{E7C7714E-CFE8-7D81-BB5D-7733637A0EBE}"/>
              </a:ext>
            </a:extLst>
          </p:cNvPr>
          <p:cNvSpPr txBox="1">
            <a:spLocks/>
          </p:cNvSpPr>
          <p:nvPr/>
        </p:nvSpPr>
        <p:spPr>
          <a:xfrm>
            <a:off x="155995" y="8121352"/>
            <a:ext cx="6172200" cy="1115900"/>
          </a:xfrm>
          <a:prstGeom prst="rect">
            <a:avLst/>
          </a:prstGeom>
        </p:spPr>
        <p:txBody>
          <a:bodyPr vert="horz" lIns="91440" tIns="45720" rIns="91440" bIns="45720" rtlCol="0">
            <a:noAutofit/>
          </a:bodyPr>
          <a:lstStyle>
            <a:lvl1pPr marL="342900" indent="-3429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kumimoji="1"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1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Cordia New" panose="020B0304020202020204" pitchFamily="34" charset="-34"/>
              </a:rPr>
              <a:t>Primers for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Cordia New" panose="020B0304020202020204" pitchFamily="34" charset="-34"/>
              </a:rPr>
              <a:t>quantitative real time polymerase chain reaction.</a:t>
            </a:r>
            <a:endParaRPr lang="ja-JP" altLang="ja-JP" sz="1200" dirty="0">
              <a:effectLst/>
              <a:latin typeface="Calibri" panose="020F0502020204030204" pitchFamily="34" charset="0"/>
              <a:ea typeface="游明朝" panose="02020400000000000000" pitchFamily="18" charset="-128"/>
              <a:cs typeface="Cordia New" panose="020B0304020202020204" pitchFamily="34" charset="-34"/>
            </a:endParaRP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C3B5F7E9-D4A9-0756-64E1-E4D7818EEE8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0048067"/>
              </p:ext>
            </p:extLst>
          </p:nvPr>
        </p:nvGraphicFramePr>
        <p:xfrm>
          <a:off x="228004" y="2072680"/>
          <a:ext cx="6441356" cy="5447390"/>
        </p:xfrm>
        <a:graphic>
          <a:graphicData uri="http://schemas.openxmlformats.org/drawingml/2006/table">
            <a:tbl>
              <a:tblPr firstRow="1" firstCol="1" bandRow="1"/>
              <a:tblGrid>
                <a:gridCol w="897327">
                  <a:extLst>
                    <a:ext uri="{9D8B030D-6E8A-4147-A177-3AD203B41FA5}">
                      <a16:colId xmlns:a16="http://schemas.microsoft.com/office/drawing/2014/main" val="2894368871"/>
                    </a:ext>
                  </a:extLst>
                </a:gridCol>
                <a:gridCol w="2795753">
                  <a:extLst>
                    <a:ext uri="{9D8B030D-6E8A-4147-A177-3AD203B41FA5}">
                      <a16:colId xmlns:a16="http://schemas.microsoft.com/office/drawing/2014/main" val="2516729312"/>
                    </a:ext>
                  </a:extLst>
                </a:gridCol>
                <a:gridCol w="2748276">
                  <a:extLst>
                    <a:ext uri="{9D8B030D-6E8A-4147-A177-3AD203B41FA5}">
                      <a16:colId xmlns:a16="http://schemas.microsoft.com/office/drawing/2014/main" val="3697176472"/>
                    </a:ext>
                  </a:extLst>
                </a:gridCol>
              </a:tblGrid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ene</a:t>
                      </a:r>
                      <a:endParaRPr lang="ja-JP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rward primer (</a:t>
                      </a: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5′-3′</a:t>
                      </a: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JP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Reverse primer (</a:t>
                      </a: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5′-3′</a:t>
                      </a:r>
                      <a:r>
                        <a:rPr lang="en-US" sz="1100" b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ja-JP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1934704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k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AGATCGCCTCCAGCCTAT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ATTACGGTCAGGATGGG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09797960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ax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GAGCTGCAGAGGATGAT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CTTGGATCCAGACAAGCAG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3355582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cl2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CTGAGTACCTGAACCGG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TTCCACAAAGGCATCCCA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31018438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β-MHC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GAGTCCCAGGTCAACA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TCACGGGCACCCTTGG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07719145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Bnp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TGGATCTCCTGAAGGTGC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TGCTGCCTTGAGACCGA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36290609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cl2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TCTGTGCTGACCCCAAGAA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GTTCCGATCCAGGTTTTT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90037897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ol1a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kumimoji="1"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TGCTAACGTGGTTCGTGACC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25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1100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ACATCTTGAGGTCGCGGCATGT</a:t>
                      </a:r>
                      <a:endParaRPr kumimoji="1" lang="ja-JP" altLang="ja-JP" sz="1100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45464110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f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TGTGATGAGCCCAAGGA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GTTGGCTCGCATCATAGT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11226271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IF5A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CCAAGGTCCATCTGGT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AGCTGCCTCCTCTGTCA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2985508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n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GAGGTGACAGAGACCACA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GGAGTCAAGCCAGACAC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21560449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FoxM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TTCTGGACCATTCACCC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TCGGTCGTTTCTGCTGTG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17485549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PDH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GCTGAGTATGTCGTGG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CAGTCTTCTGGGTGGCAG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19475343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stk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GTTCCCCTCAACATACC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GTTGCTCCATGCTTACA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4133114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gfbp7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AACCTGCGAATCCATGAG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GAGAAGTGTGTCAGGCAAGA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6450313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6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GAGCCCACCAGGAACGAAAGT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TGGCTGGAAGTCTCTTGCGGA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48239611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l10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TGCCCCAGGCAGAGA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CCCAGGGAATTCAAATG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02550279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Klf5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GTTGCACAAAAGTTTATA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TTGGCGCCCGTGTGCTTC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77799303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Nox4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TGGCCAACGAAGGGGTTAA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CCCTTGGTTGTACAGCAGAG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95729933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AI-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GCCATTACTACGACATCC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TCATGTTGCCTTTCCAG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88924598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KC</a:t>
                      </a: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  <a:sym typeface="Symbol" panose="05050102010706020507" pitchFamily="18" charset="2"/>
                        </a:rPr>
                        <a:t>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ATTGCCGACTTTGGGATG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游明朝" panose="02020400000000000000" pitchFamily="18" charset="-128"/>
                          <a:cs typeface="Times New Roman" panose="02020603050405020304" pitchFamily="18" charset="0"/>
                        </a:rPr>
                        <a:t>GACCACCAGTCCACAGAGA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48741939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AR-α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CAAACTTGGACTTGAAC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ATCAGCATCCCGTCTTTG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07230558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AR-δ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GAACAGCCACAGGAGGAGA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CCCATCACAGCCCATC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75926797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PAR-γ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AGAGCTGACCCAATGGTTG</a:t>
                      </a:r>
                      <a:endParaRPr lang="ja-JP" sz="1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50" charset="-128"/>
                          <a:cs typeface="Times New Roman" panose="02020603050405020304" pitchFamily="18" charset="0"/>
                        </a:rPr>
                        <a:t>ACCCTTGCATCCTTCACAA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91277835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gfb1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TCCCGTGGCTTCTAGTGC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CCTTAGTTTGGACAGGATCTG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15248968"/>
                  </a:ext>
                </a:extLst>
              </a:tr>
              <a:tr h="209515"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i="1" dirty="0" err="1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Tnfa</a:t>
                      </a:r>
                      <a:endParaRPr lang="ja-JP" sz="1100" i="1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CAGCCGATGGGTTGTACCTT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25000"/>
                        </a:lnSpc>
                        <a:spcAft>
                          <a:spcPts val="800"/>
                        </a:spcAft>
                      </a:pPr>
                      <a:r>
                        <a:rPr lang="en-US" sz="1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GGCAGCCTTGTCCCTTGA</a:t>
                      </a:r>
                      <a:endParaRPr lang="ja-JP" sz="1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游明朝" panose="02020400000000000000" pitchFamily="18" charset="-128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8735874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55217330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33A82DE-7EA3-27F0-BBBD-3D376DD1CF99}"/>
              </a:ext>
            </a:extLst>
          </p:cNvPr>
          <p:cNvSpPr txBox="1"/>
          <p:nvPr/>
        </p:nvSpPr>
        <p:spPr>
          <a:xfrm>
            <a:off x="229765" y="6105128"/>
            <a:ext cx="6398469" cy="24354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</a:t>
            </a:r>
            <a:r>
              <a:rPr lang="th-TH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hocardiographic measurements in 0-week mice (Pre-TAC).</a:t>
            </a:r>
            <a:endParaRPr lang="en-US" altLang="ja-JP" sz="1200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VS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IVSs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ID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ntricular internal diameter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IDs, left ventricular internal dimension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PW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PWs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LVED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ic volume; LVES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ic volume; LV mass (corrected); LVEF, left ventricular ejection fraction; LVFS, left ventricular fractional shortening; HR, heart rate; bpm, beats per minute. The statistical significance of distributed data was analyzed by one-way ANOVA followed by Tukey’s multiple comparisons test. (n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0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group)</a:t>
            </a:r>
            <a:endParaRPr lang="ja-JP" altLang="ja-JP" sz="12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444D83DC-64C7-2FC3-1948-8D424C2BB2E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8550315"/>
              </p:ext>
            </p:extLst>
          </p:nvPr>
        </p:nvGraphicFramePr>
        <p:xfrm>
          <a:off x="482600" y="2072680"/>
          <a:ext cx="5892800" cy="3429000"/>
        </p:xfrm>
        <a:graphic>
          <a:graphicData uri="http://schemas.openxmlformats.org/drawingml/2006/table">
            <a:tbl>
              <a:tblPr/>
              <a:tblGrid>
                <a:gridCol w="1206500">
                  <a:extLst>
                    <a:ext uri="{9D8B030D-6E8A-4147-A177-3AD203B41FA5}">
                      <a16:colId xmlns:a16="http://schemas.microsoft.com/office/drawing/2014/main" val="3841054541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577938007"/>
                    </a:ext>
                  </a:extLst>
                </a:gridCol>
                <a:gridCol w="1155700">
                  <a:extLst>
                    <a:ext uri="{9D8B030D-6E8A-4147-A177-3AD203B41FA5}">
                      <a16:colId xmlns:a16="http://schemas.microsoft.com/office/drawing/2014/main" val="182862433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3530139458"/>
                    </a:ext>
                  </a:extLst>
                </a:gridCol>
                <a:gridCol w="1206500">
                  <a:extLst>
                    <a:ext uri="{9D8B030D-6E8A-4147-A177-3AD203B41FA5}">
                      <a16:colId xmlns:a16="http://schemas.microsoft.com/office/drawing/2014/main" val="950428498"/>
                    </a:ext>
                  </a:extLst>
                </a:gridCol>
              </a:tblGrid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roups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T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am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 + NC114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4553451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6 ± 0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6 ± 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8 ± 0.0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2 ± 0.0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212838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02 ± 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6 ± 0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1 ± 0.0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6 ± 0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8587328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52 ± 0.3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9 ± 0.3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1 ± 0.3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3 ± 0.2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3939402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3 ± 0.1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3 ± 0.1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8 ± 0.2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9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0879939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2 ± 0.2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3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5 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6 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322548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22 ± 0.1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5 ± 0.1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20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20 ± 0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189118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D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2.31 ± 10.5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.08 ± 10.8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.52 ± 11.3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.83 ± 10.4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237553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S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.96 ± 3.7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05 ± 4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.95 ± 4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.02 ± 3.3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69685132"/>
                  </a:ext>
                </a:extLst>
              </a:tr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 mass (corrected) (mg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6.79 ± 17.0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8.16 ± 14.6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3.14 ± 19.6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6.20 ± 17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592047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F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72 ± 0.5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80 ± 0.5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.09 ± 0.7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.02 ± 1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3301199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FS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82 ± 0.4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99 ± 0.3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16 ± 0.5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13 ± 0.9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1384594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R (beats/min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5.70 ± 26.7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7.50 ± 25.0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9.80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± 22.67</a:t>
                      </a:r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游ゴシック" panose="020B0400000000000000" pitchFamily="50" charset="-128"/>
                      </a:endParaRP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8.60 ± 21.8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05512086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B75B74FC-69BA-0D4E-EE01-48DCEB50A3FF}"/>
              </a:ext>
            </a:extLst>
          </p:cNvPr>
          <p:cNvSpPr txBox="1"/>
          <p:nvPr/>
        </p:nvSpPr>
        <p:spPr>
          <a:xfrm>
            <a:off x="2996952" y="1226962"/>
            <a:ext cx="10081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i="0" dirty="0">
                <a:solidFill>
                  <a:srgbClr val="1A1A1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e-TAC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186909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7C5CE8A6-E6AF-19B0-55CC-26AF914AE34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7DBE54B6-D01B-5B07-EB03-3D36E6A7AAD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55414410"/>
              </p:ext>
            </p:extLst>
          </p:nvPr>
        </p:nvGraphicFramePr>
        <p:xfrm>
          <a:off x="660400" y="2000672"/>
          <a:ext cx="5720928" cy="3429000"/>
        </p:xfrm>
        <a:graphic>
          <a:graphicData uri="http://schemas.openxmlformats.org/drawingml/2006/table">
            <a:tbl>
              <a:tblPr/>
              <a:tblGrid>
                <a:gridCol w="1166061">
                  <a:extLst>
                    <a:ext uri="{9D8B030D-6E8A-4147-A177-3AD203B41FA5}">
                      <a16:colId xmlns:a16="http://schemas.microsoft.com/office/drawing/2014/main" val="446906854"/>
                    </a:ext>
                  </a:extLst>
                </a:gridCol>
                <a:gridCol w="1101280">
                  <a:extLst>
                    <a:ext uri="{9D8B030D-6E8A-4147-A177-3AD203B41FA5}">
                      <a16:colId xmlns:a16="http://schemas.microsoft.com/office/drawing/2014/main" val="3938042603"/>
                    </a:ext>
                  </a:extLst>
                </a:gridCol>
                <a:gridCol w="1088324">
                  <a:extLst>
                    <a:ext uri="{9D8B030D-6E8A-4147-A177-3AD203B41FA5}">
                      <a16:colId xmlns:a16="http://schemas.microsoft.com/office/drawing/2014/main" val="1459835991"/>
                    </a:ext>
                  </a:extLst>
                </a:gridCol>
                <a:gridCol w="1217886">
                  <a:extLst>
                    <a:ext uri="{9D8B030D-6E8A-4147-A177-3AD203B41FA5}">
                      <a16:colId xmlns:a16="http://schemas.microsoft.com/office/drawing/2014/main" val="65595566"/>
                    </a:ext>
                  </a:extLst>
                </a:gridCol>
                <a:gridCol w="1147377">
                  <a:extLst>
                    <a:ext uri="{9D8B030D-6E8A-4147-A177-3AD203B41FA5}">
                      <a16:colId xmlns:a16="http://schemas.microsoft.com/office/drawing/2014/main" val="1840294526"/>
                    </a:ext>
                  </a:extLst>
                </a:gridCol>
              </a:tblGrid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roups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T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am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 + NC114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29061923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0 ± 0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6 ± 0.0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2 ± 0.0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0 ± 0.0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287639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4 ± 0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8 ± 0.1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06 ± 0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9 ± 0.0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98869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50 ± 0.3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1 ± 0.2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48 ± 0.2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52 ± 0.2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2083172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3 ± 0.1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6 ± 0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5 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9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994368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4 ± 0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8 ± 0.0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2 ± 0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1 ± 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556312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23 ± 0.1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7 ± 0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20 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09 ± 0.1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6395674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D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49 ± 1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.81 ± 8.3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.62 ± 8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77 ± 8.2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5271113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S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.92 ± 3.6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62 ± 3.0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34 ± 3.4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.11 ± 3.2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3571576"/>
                  </a:ext>
                </a:extLst>
              </a:tr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 mass (corrected) (mg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5.72 ± 13.8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6.36 ± 10.2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1.96 ± 13.08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77.22 ± 10.37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344969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F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19 ± 0.7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24 ± 0.42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9.63 ± 1.30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.14 ± 1.04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052623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FS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42 ± 0.7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62 ± 0.3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0.99 ± 0.8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1.98 ± 0.8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6269404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R (beats/min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1.60 ± 23.8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5.90 ± 31.3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76.50 ± 22.45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2.70 ± 21.51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19580557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23D5E903-EB18-B40B-2F4C-A2B823100596}"/>
              </a:ext>
            </a:extLst>
          </p:cNvPr>
          <p:cNvSpPr txBox="1"/>
          <p:nvPr/>
        </p:nvSpPr>
        <p:spPr>
          <a:xfrm>
            <a:off x="200020" y="6105128"/>
            <a:ext cx="6398469" cy="32305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3.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hocardiographic measurements in 1-week mice (Post-TAC).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VS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IVSs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ID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ntricular internal diameter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IDs, left ventricular internal dimension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PW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PWs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LVED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ic volume; LVES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ic volume; LV mass (corrected); LVEF, left ventricular ejection fraction; LVFS, left ventricular fractional shortening; HR, heart rate; bpm, beats per minute. The statistical significance of distributed data was analyzed by one-way ANOVA followed by Tukey’s multiple comparisons test. (n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0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group)</a:t>
            </a:r>
            <a:b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 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&lt; 0.0001 sham vs. NC114</a:t>
            </a:r>
            <a:b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# 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&lt; 0.01 vehicle (untreated TAC mice) vs. NC114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  <a:endParaRPr lang="ja-JP" altLang="ja-JP" sz="12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475393FF-2010-EC70-00CA-21D9CCC95033}"/>
              </a:ext>
            </a:extLst>
          </p:cNvPr>
          <p:cNvSpPr txBox="1"/>
          <p:nvPr/>
        </p:nvSpPr>
        <p:spPr>
          <a:xfrm>
            <a:off x="2996952" y="1226962"/>
            <a:ext cx="10081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i="0" dirty="0">
                <a:solidFill>
                  <a:srgbClr val="1A1A1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st-TAC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2789351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4CB8C17-03DC-9BFA-C0C5-48B228BC625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FE3DB8CF-E25B-F0AE-EA9E-25E7024D8AE7}"/>
              </a:ext>
            </a:extLst>
          </p:cNvPr>
          <p:cNvSpPr txBox="1"/>
          <p:nvPr/>
        </p:nvSpPr>
        <p:spPr>
          <a:xfrm>
            <a:off x="200020" y="6105128"/>
            <a:ext cx="6398469" cy="24354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4.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hocardiographic measurements in 0-week mice (Pre-TAC).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VS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IVSs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ID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ntricular internal diameter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IDs, left ventricular internal dimension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PW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PWs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LVED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ic volume; LVES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ic volume; LV mass (corrected); LVEF, left ventricular ejection fraction; LVFS, left ventricular fractional shortening; HR, heart rate; bpm, beats per minute. The statistical significance of distributed data was analyzed by one-way ANOVA followed by Tukey’s multiple comparisons test. (n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0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group)</a:t>
            </a:r>
            <a:endParaRPr lang="ja-JP" altLang="ja-JP" sz="12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2FD84EA0-B942-AA90-2242-C5538B19F2D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40323794"/>
              </p:ext>
            </p:extLst>
          </p:nvPr>
        </p:nvGraphicFramePr>
        <p:xfrm>
          <a:off x="482600" y="2072680"/>
          <a:ext cx="5892800" cy="3429000"/>
        </p:xfrm>
        <a:graphic>
          <a:graphicData uri="http://schemas.openxmlformats.org/drawingml/2006/table">
            <a:tbl>
              <a:tblPr/>
              <a:tblGrid>
                <a:gridCol w="1206500">
                  <a:extLst>
                    <a:ext uri="{9D8B030D-6E8A-4147-A177-3AD203B41FA5}">
                      <a16:colId xmlns:a16="http://schemas.microsoft.com/office/drawing/2014/main" val="3025058997"/>
                    </a:ext>
                  </a:extLst>
                </a:gridCol>
                <a:gridCol w="1092200">
                  <a:extLst>
                    <a:ext uri="{9D8B030D-6E8A-4147-A177-3AD203B41FA5}">
                      <a16:colId xmlns:a16="http://schemas.microsoft.com/office/drawing/2014/main" val="2370782148"/>
                    </a:ext>
                  </a:extLst>
                </a:gridCol>
                <a:gridCol w="1155700">
                  <a:extLst>
                    <a:ext uri="{9D8B030D-6E8A-4147-A177-3AD203B41FA5}">
                      <a16:colId xmlns:a16="http://schemas.microsoft.com/office/drawing/2014/main" val="2316946175"/>
                    </a:ext>
                  </a:extLst>
                </a:gridCol>
                <a:gridCol w="1231900">
                  <a:extLst>
                    <a:ext uri="{9D8B030D-6E8A-4147-A177-3AD203B41FA5}">
                      <a16:colId xmlns:a16="http://schemas.microsoft.com/office/drawing/2014/main" val="1293393299"/>
                    </a:ext>
                  </a:extLst>
                </a:gridCol>
                <a:gridCol w="1206500">
                  <a:extLst>
                    <a:ext uri="{9D8B030D-6E8A-4147-A177-3AD203B41FA5}">
                      <a16:colId xmlns:a16="http://schemas.microsoft.com/office/drawing/2014/main" val="1531597276"/>
                    </a:ext>
                  </a:extLst>
                </a:gridCol>
              </a:tblGrid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roups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T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am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 + NC114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736557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5 ± 0.1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6 ± 0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2 ± 0.1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9 ± 0.0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6242549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7 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0 ± 0.1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1 ± 0.0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9 ± 0.0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35991206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0 ± 0.1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52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7 ± 0.3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1 ± 0.2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9607654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2 ± 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0 ± 0.0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9 ± 0.2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37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353057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8 ± 0.1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1 ± 0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2 ± 0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6 ± 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1452678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6 ± 0.1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3 ± 0.1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5 ± 0.1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8 ± 0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017156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DV (</a:t>
                      </a:r>
                      <a:r>
                        <a:rPr lang="el-GR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8.20 ± 7.3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1.76 ± 5.5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7.77 ± 14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.25 ± 9.0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61126962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S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.78 ± 2.8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8.22 ± 1.5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.38 ± 5.0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9.62 ± 3.4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5795829"/>
                  </a:ext>
                </a:extLst>
              </a:tr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 mass (corrected) (mg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4.99 ± 15.6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1.32 ± 14.49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5.72 ± 22.7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3.24 ± 14.0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4781207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F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.32 ± 0.9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.72 ± 0.9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.80 ± 1.0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4.54 ± 0.8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1256598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FS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40 ± 0.6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56 ± 0.7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71 ± 0.6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49 ± 0.5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18913622"/>
                  </a:ext>
                </a:extLst>
              </a:tr>
              <a:tr h="25908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R (beats/min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7.50 ± 16.9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9.90 ± 18.5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50.30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游明朝" panose="02020400000000000000" pitchFamily="18" charset="-128"/>
                          <a:ea typeface="游明朝" panose="02020400000000000000" pitchFamily="18" charset="-128"/>
                        </a:rPr>
                        <a:t>± </a:t>
                      </a:r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5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9.60 ± 15.8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27914300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2B92B255-8E69-1868-8690-DBCE4E221F3A}"/>
              </a:ext>
            </a:extLst>
          </p:cNvPr>
          <p:cNvSpPr txBox="1"/>
          <p:nvPr/>
        </p:nvSpPr>
        <p:spPr>
          <a:xfrm>
            <a:off x="2996952" y="1226962"/>
            <a:ext cx="10081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i="0" dirty="0">
                <a:solidFill>
                  <a:srgbClr val="1A1A1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re-TAC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585458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2504CF-1E44-27C5-D64E-E931599952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30B4885B-A676-3C2B-FE0F-86CFBB91FF6A}"/>
              </a:ext>
            </a:extLst>
          </p:cNvPr>
          <p:cNvSpPr txBox="1"/>
          <p:nvPr/>
        </p:nvSpPr>
        <p:spPr>
          <a:xfrm>
            <a:off x="200020" y="6105128"/>
            <a:ext cx="6398469" cy="28970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indent="0">
              <a:buFont typeface="Arial" panose="020B0604020202020204" pitchFamily="34" charset="0"/>
              <a:buNone/>
            </a:pPr>
            <a:r>
              <a:rPr lang="en-US" altLang="ja-JP" sz="1200" b="1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5.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b="1" kern="1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Echocardiographic measurements in 4-week mice (Post-TAC).</a:t>
            </a:r>
            <a:r>
              <a:rPr lang="en-US" altLang="ja-JP" sz="120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pPr marL="0" indent="0">
              <a:lnSpc>
                <a:spcPct val="125000"/>
              </a:lnSpc>
              <a:spcAft>
                <a:spcPts val="800"/>
              </a:spcAft>
              <a:buNone/>
            </a:pP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IVS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IVSs, interventricular septum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ID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ventricular internal diameter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IDs, left ventricular internal dimension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</a:t>
            </a:r>
            <a:r>
              <a:rPr lang="en-US" altLang="ja-JP" sz="12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LVPW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e; LVPWs, left ventricular posterior wall depth at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e; LVED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iastolic volume; LVESV, left ventricular end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ystolic volume; LV mass (corrected); LVEF, left ventricular ejection fraction; LVFS, left ventricular fractional shortening; HR, heart rate; bpm, beats per minute. The statistical significance of distributed data was analyzed by one-way ANOVA followed by Tukey’s multiple comparisons test. (n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=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0 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er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group)</a:t>
            </a:r>
            <a:b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 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&lt; 0.001 sham vs. NC114</a:t>
            </a:r>
            <a:b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</a:b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# </a:t>
            </a:r>
            <a:r>
              <a:rPr lang="en-US" altLang="ja-JP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</a:t>
            </a:r>
            <a:r>
              <a:rPr lang="en-US" altLang="ja-JP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&lt; 0.0001 vehicle (untreated TAC mice) vs. NC114 </a:t>
            </a:r>
            <a:endParaRPr lang="ja-JP" altLang="ja-JP" sz="12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029DA147-3478-4540-9912-E09ACF89C19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96984014"/>
              </p:ext>
            </p:extLst>
          </p:nvPr>
        </p:nvGraphicFramePr>
        <p:xfrm>
          <a:off x="660400" y="2000672"/>
          <a:ext cx="5864944" cy="3406140"/>
        </p:xfrm>
        <a:graphic>
          <a:graphicData uri="http://schemas.openxmlformats.org/drawingml/2006/table">
            <a:tbl>
              <a:tblPr/>
              <a:tblGrid>
                <a:gridCol w="1210653">
                  <a:extLst>
                    <a:ext uri="{9D8B030D-6E8A-4147-A177-3AD203B41FA5}">
                      <a16:colId xmlns:a16="http://schemas.microsoft.com/office/drawing/2014/main" val="3549284341"/>
                    </a:ext>
                  </a:extLst>
                </a:gridCol>
                <a:gridCol w="1143395">
                  <a:extLst>
                    <a:ext uri="{9D8B030D-6E8A-4147-A177-3AD203B41FA5}">
                      <a16:colId xmlns:a16="http://schemas.microsoft.com/office/drawing/2014/main" val="1312140201"/>
                    </a:ext>
                  </a:extLst>
                </a:gridCol>
                <a:gridCol w="1129944">
                  <a:extLst>
                    <a:ext uri="{9D8B030D-6E8A-4147-A177-3AD203B41FA5}">
                      <a16:colId xmlns:a16="http://schemas.microsoft.com/office/drawing/2014/main" val="2161075708"/>
                    </a:ext>
                  </a:extLst>
                </a:gridCol>
                <a:gridCol w="1156816">
                  <a:extLst>
                    <a:ext uri="{9D8B030D-6E8A-4147-A177-3AD203B41FA5}">
                      <a16:colId xmlns:a16="http://schemas.microsoft.com/office/drawing/2014/main" val="3034891973"/>
                    </a:ext>
                  </a:extLst>
                </a:gridCol>
                <a:gridCol w="1224136">
                  <a:extLst>
                    <a:ext uri="{9D8B030D-6E8A-4147-A177-3AD203B41FA5}">
                      <a16:colId xmlns:a16="http://schemas.microsoft.com/office/drawing/2014/main" val="3062917023"/>
                    </a:ext>
                  </a:extLst>
                </a:gridCol>
              </a:tblGrid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Groups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T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am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TAC + NC114 (n = 10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8411353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0 ± 0.1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4 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39 ± 0.30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85 ± 0.09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1504004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IVS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9 ± 0.1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01 ± 0.1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7 ± 0.12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00 ± 0.15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20777109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60 ± 0.21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58 ± 0.13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.18 ± 0.26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73 ± 0.16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99050887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ID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4 ± 0.14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41 ± 0.15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.21 ± 0.26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.70 ± 0.15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984648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d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2 ± 0.1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68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96 ± 0.14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0.76 ± 0.09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415408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PWs (mm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4 ± 0.1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3 ± 0.12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37 ± 0.24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.11 ± 0.05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1461770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D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.43 ± 5.4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.54 ± 4.99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1.32 ± 7.37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1.97 ± 5.85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7809904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SV (</a:t>
                      </a:r>
                      <a:r>
                        <a:rPr lang="el-GR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μ</a:t>
                      </a:r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2 ± 3.98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.50 ± 3.39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4.88 ± 7.22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8.80 ± 5.36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4509671"/>
                  </a:ext>
                </a:extLst>
              </a:tr>
              <a:tr h="40386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 mass (corrected) (mg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4.75 ± 8.67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85.98 ± 10.93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118.97 ± 14.66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95.66 ± 4.63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45697220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EF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86 ± 0.6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63.73 ± 1.20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42.61 ± 4.99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6.52 ± 1.39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956515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LVFS (%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4.09 ± 0.45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33.90 ±0.87⁎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0.66 ± 2.72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9.06 ± 0.94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1611801"/>
                  </a:ext>
                </a:extLst>
              </a:tr>
              <a:tr h="236220"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sz="12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HR (beats/min)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3.50 ± 28.60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41.60 ± 23.96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00.50 ± 14.56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t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530.70 ± 18.59#</a:t>
                      </a:r>
                    </a:p>
                  </a:txBody>
                  <a:tcPr marL="7620" marR="7620" marT="762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4220144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EEACE5F-5899-1025-68C9-ED4C70D6B595}"/>
              </a:ext>
            </a:extLst>
          </p:cNvPr>
          <p:cNvSpPr txBox="1"/>
          <p:nvPr/>
        </p:nvSpPr>
        <p:spPr>
          <a:xfrm>
            <a:off x="2996952" y="1226962"/>
            <a:ext cx="100811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i="0" dirty="0">
                <a:solidFill>
                  <a:srgbClr val="1A1A1A"/>
                </a:solidFill>
                <a:effectLst/>
                <a:latin typeface="Times New Roman" panose="02020603050405020304" pitchFamily="18" charset="0"/>
                <a:cs typeface="Times New Roman" panose="02020603050405020304" pitchFamily="18" charset="0"/>
              </a:rPr>
              <a:t>Post-TAC</a:t>
            </a:r>
            <a:endParaRPr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854808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A62504CF-1E44-27C5-D64E-E931599952FC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>
            <a:extLst>
              <a:ext uri="{FF2B5EF4-FFF2-40B4-BE49-F238E27FC236}">
                <a16:creationId xmlns:a16="http://schemas.microsoft.com/office/drawing/2014/main" id="{3179CA99-3E0C-30DC-C54C-2A5A6AF4F2C5}"/>
              </a:ext>
            </a:extLst>
          </p:cNvPr>
          <p:cNvSpPr txBox="1"/>
          <p:nvPr/>
        </p:nvSpPr>
        <p:spPr>
          <a:xfrm>
            <a:off x="338194" y="4521627"/>
            <a:ext cx="3427372" cy="2927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JP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AC vehicle Group (n = 10)</a:t>
            </a:r>
            <a:endParaRPr lang="en-JP" sz="1200" kern="1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B89F3D26-BF6C-E969-2DB8-DCFE50FE05A4}"/>
              </a:ext>
            </a:extLst>
          </p:cNvPr>
          <p:cNvSpPr txBox="1"/>
          <p:nvPr/>
        </p:nvSpPr>
        <p:spPr>
          <a:xfrm>
            <a:off x="346428" y="6697044"/>
            <a:ext cx="3427372" cy="292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JP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C114-</a:t>
            </a:r>
            <a:r>
              <a:rPr lang="en-US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JP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ated TAC Group (n = 10)</a:t>
            </a:r>
            <a:endParaRPr lang="en-JP" sz="1200" kern="1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A98C938-ADB7-5D88-D3E2-7D2A5A3A6F11}"/>
              </a:ext>
            </a:extLst>
          </p:cNvPr>
          <p:cNvSpPr txBox="1"/>
          <p:nvPr/>
        </p:nvSpPr>
        <p:spPr>
          <a:xfrm>
            <a:off x="332656" y="130300"/>
            <a:ext cx="3427372" cy="2927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JP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 (n = 10)</a:t>
            </a:r>
            <a:endParaRPr lang="en-JP" sz="1200" kern="1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3066F33D-6FD8-6FE0-54EF-110D7D3CA962}"/>
              </a:ext>
            </a:extLst>
          </p:cNvPr>
          <p:cNvSpPr txBox="1"/>
          <p:nvPr/>
        </p:nvSpPr>
        <p:spPr>
          <a:xfrm>
            <a:off x="332656" y="2345857"/>
            <a:ext cx="3427372" cy="29270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  <a:buNone/>
            </a:pPr>
            <a:r>
              <a:rPr lang="en-US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ham </a:t>
            </a:r>
            <a:r>
              <a:rPr lang="en-JP" sz="1200" b="1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roup (n = 10)</a:t>
            </a:r>
            <a:endParaRPr lang="en-JP" sz="1200" kern="100" dirty="0">
              <a:effectLst/>
              <a:latin typeface="Times New Roman" panose="02020603050405020304" pitchFamily="18" charset="0"/>
              <a:ea typeface="Yu Mincho" panose="02020400000000000000" pitchFamily="18" charset="-128"/>
              <a:cs typeface="Times New Roman" panose="02020603050405020304" pitchFamily="18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13DCB7A5-06EA-8062-51E5-CE1F67E0053B}"/>
              </a:ext>
            </a:extLst>
          </p:cNvPr>
          <p:cNvSpPr txBox="1"/>
          <p:nvPr/>
        </p:nvSpPr>
        <p:spPr>
          <a:xfrm>
            <a:off x="104823" y="8833881"/>
            <a:ext cx="664835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Table 6.</a:t>
            </a:r>
            <a:b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ody-weight data from days 1–10 after TAC surgery.</a:t>
            </a:r>
            <a:b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-US" altLang="ja-JP" sz="1200" kern="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 table shows the body-weight measurements for four groups of mice from days 1–10 following TAC surgery (n = 10 per group: WT [W1–W10], Sham [Sh1–Sh10], Vehicle [V1–V10], and NC114 [N1–N10]). Weight D1–D10 = Weight Day 1–Day 10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E6D8CAC5-4A0F-79CC-1D56-DB28A0F1F6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00211387"/>
              </p:ext>
            </p:extLst>
          </p:nvPr>
        </p:nvGraphicFramePr>
        <p:xfrm>
          <a:off x="174272" y="420287"/>
          <a:ext cx="6564541" cy="1905700"/>
        </p:xfrm>
        <a:graphic>
          <a:graphicData uri="http://schemas.openxmlformats.org/drawingml/2006/table">
            <a:tbl>
              <a:tblPr/>
              <a:tblGrid>
                <a:gridCol w="524357">
                  <a:extLst>
                    <a:ext uri="{9D8B030D-6E8A-4147-A177-3AD203B41FA5}">
                      <a16:colId xmlns:a16="http://schemas.microsoft.com/office/drawing/2014/main" val="1802318261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484334816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1767794894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3448937973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2735301891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313891098"/>
                    </a:ext>
                  </a:extLst>
                </a:gridCol>
                <a:gridCol w="625195">
                  <a:extLst>
                    <a:ext uri="{9D8B030D-6E8A-4147-A177-3AD203B41FA5}">
                      <a16:colId xmlns:a16="http://schemas.microsoft.com/office/drawing/2014/main" val="3541336720"/>
                    </a:ext>
                  </a:extLst>
                </a:gridCol>
                <a:gridCol w="584859">
                  <a:extLst>
                    <a:ext uri="{9D8B030D-6E8A-4147-A177-3AD203B41FA5}">
                      <a16:colId xmlns:a16="http://schemas.microsoft.com/office/drawing/2014/main" val="4277356400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3484499472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2848531263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639371208"/>
                    </a:ext>
                  </a:extLst>
                </a:gridCol>
              </a:tblGrid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4819549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5336681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2388261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2444694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1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3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2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8523840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5413981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62169080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9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3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6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06042356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5783137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692846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60405021"/>
                  </a:ext>
                </a:extLst>
              </a:tr>
              <a:tr h="27874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an±SD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5±0.9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6±0.9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5±0.9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9±0.8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8±0.7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8±0.7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±0.8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7±0.8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1±0.8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9±0.8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89021662"/>
                  </a:ext>
                </a:extLst>
              </a:tr>
            </a:tbl>
          </a:graphicData>
        </a:graphic>
      </p:graphicFrame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A5189388-5024-86EE-101F-9A5035C1F85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66964436"/>
              </p:ext>
            </p:extLst>
          </p:nvPr>
        </p:nvGraphicFramePr>
        <p:xfrm>
          <a:off x="174272" y="2647419"/>
          <a:ext cx="6564541" cy="1905700"/>
        </p:xfrm>
        <a:graphic>
          <a:graphicData uri="http://schemas.openxmlformats.org/drawingml/2006/table">
            <a:tbl>
              <a:tblPr/>
              <a:tblGrid>
                <a:gridCol w="524357">
                  <a:extLst>
                    <a:ext uri="{9D8B030D-6E8A-4147-A177-3AD203B41FA5}">
                      <a16:colId xmlns:a16="http://schemas.microsoft.com/office/drawing/2014/main" val="1503519173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1703765847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741608309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1662665595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2883066304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2218220597"/>
                    </a:ext>
                  </a:extLst>
                </a:gridCol>
                <a:gridCol w="625195">
                  <a:extLst>
                    <a:ext uri="{9D8B030D-6E8A-4147-A177-3AD203B41FA5}">
                      <a16:colId xmlns:a16="http://schemas.microsoft.com/office/drawing/2014/main" val="669596944"/>
                    </a:ext>
                  </a:extLst>
                </a:gridCol>
                <a:gridCol w="584859">
                  <a:extLst>
                    <a:ext uri="{9D8B030D-6E8A-4147-A177-3AD203B41FA5}">
                      <a16:colId xmlns:a16="http://schemas.microsoft.com/office/drawing/2014/main" val="603616208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193306806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3373371432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2257711106"/>
                    </a:ext>
                  </a:extLst>
                </a:gridCol>
              </a:tblGrid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63920634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8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08892487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3117472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57856038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45227537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54157563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8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02005432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58315801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5473483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723150325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Sh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48991781"/>
                  </a:ext>
                </a:extLst>
              </a:tr>
              <a:tr h="27874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an±SD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4±1.0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2±0.8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8±0.7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3±0.6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1±0.8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7±0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4±0.8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1±0.8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7±0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4±0.7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2286521"/>
                  </a:ext>
                </a:extLst>
              </a:tr>
            </a:tbl>
          </a:graphicData>
        </a:graphic>
      </p:graphicFrame>
      <p:graphicFrame>
        <p:nvGraphicFramePr>
          <p:cNvPr id="11" name="Table 10">
            <a:extLst>
              <a:ext uri="{FF2B5EF4-FFF2-40B4-BE49-F238E27FC236}">
                <a16:creationId xmlns:a16="http://schemas.microsoft.com/office/drawing/2014/main" id="{EBE210EF-B23E-EE24-6063-3D101415D59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61299560"/>
              </p:ext>
            </p:extLst>
          </p:nvPr>
        </p:nvGraphicFramePr>
        <p:xfrm>
          <a:off x="174272" y="4796084"/>
          <a:ext cx="6564541" cy="1905700"/>
        </p:xfrm>
        <a:graphic>
          <a:graphicData uri="http://schemas.openxmlformats.org/drawingml/2006/table">
            <a:tbl>
              <a:tblPr/>
              <a:tblGrid>
                <a:gridCol w="524357">
                  <a:extLst>
                    <a:ext uri="{9D8B030D-6E8A-4147-A177-3AD203B41FA5}">
                      <a16:colId xmlns:a16="http://schemas.microsoft.com/office/drawing/2014/main" val="1238850450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228497751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3594092647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3243698752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2546916416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991632712"/>
                    </a:ext>
                  </a:extLst>
                </a:gridCol>
                <a:gridCol w="625195">
                  <a:extLst>
                    <a:ext uri="{9D8B030D-6E8A-4147-A177-3AD203B41FA5}">
                      <a16:colId xmlns:a16="http://schemas.microsoft.com/office/drawing/2014/main" val="2172029667"/>
                    </a:ext>
                  </a:extLst>
                </a:gridCol>
                <a:gridCol w="584859">
                  <a:extLst>
                    <a:ext uri="{9D8B030D-6E8A-4147-A177-3AD203B41FA5}">
                      <a16:colId xmlns:a16="http://schemas.microsoft.com/office/drawing/2014/main" val="1600270134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3487411404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267972030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1663181414"/>
                    </a:ext>
                  </a:extLst>
                </a:gridCol>
              </a:tblGrid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90755865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80641144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95991123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5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25046585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82486059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22040264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8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68709190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5776673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1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9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8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8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5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3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9523625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74306394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V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04426420"/>
                  </a:ext>
                </a:extLst>
              </a:tr>
              <a:tr h="27874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an±SD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5±0.8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1±0.7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1±0.7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9±0.7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3±0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1±0.6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7±0.6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6±0.8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8±0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3±0.7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23183186"/>
                  </a:ext>
                </a:extLst>
              </a:tr>
            </a:tbl>
          </a:graphicData>
        </a:graphic>
      </p:graphicFrame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409EECFC-F109-57F3-A630-A73BBE80C8F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3311097"/>
              </p:ext>
            </p:extLst>
          </p:nvPr>
        </p:nvGraphicFramePr>
        <p:xfrm>
          <a:off x="174272" y="6956324"/>
          <a:ext cx="6564541" cy="1905700"/>
        </p:xfrm>
        <a:graphic>
          <a:graphicData uri="http://schemas.openxmlformats.org/drawingml/2006/table">
            <a:tbl>
              <a:tblPr/>
              <a:tblGrid>
                <a:gridCol w="524357">
                  <a:extLst>
                    <a:ext uri="{9D8B030D-6E8A-4147-A177-3AD203B41FA5}">
                      <a16:colId xmlns:a16="http://schemas.microsoft.com/office/drawing/2014/main" val="1915461327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970743072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1548359265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2474152469"/>
                    </a:ext>
                  </a:extLst>
                </a:gridCol>
                <a:gridCol w="615110">
                  <a:extLst>
                    <a:ext uri="{9D8B030D-6E8A-4147-A177-3AD203B41FA5}">
                      <a16:colId xmlns:a16="http://schemas.microsoft.com/office/drawing/2014/main" val="479003158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2747585633"/>
                    </a:ext>
                  </a:extLst>
                </a:gridCol>
                <a:gridCol w="625195">
                  <a:extLst>
                    <a:ext uri="{9D8B030D-6E8A-4147-A177-3AD203B41FA5}">
                      <a16:colId xmlns:a16="http://schemas.microsoft.com/office/drawing/2014/main" val="1466586139"/>
                    </a:ext>
                  </a:extLst>
                </a:gridCol>
                <a:gridCol w="584859">
                  <a:extLst>
                    <a:ext uri="{9D8B030D-6E8A-4147-A177-3AD203B41FA5}">
                      <a16:colId xmlns:a16="http://schemas.microsoft.com/office/drawing/2014/main" val="2444427908"/>
                    </a:ext>
                  </a:extLst>
                </a:gridCol>
                <a:gridCol w="594943">
                  <a:extLst>
                    <a:ext uri="{9D8B030D-6E8A-4147-A177-3AD203B41FA5}">
                      <a16:colId xmlns:a16="http://schemas.microsoft.com/office/drawing/2014/main" val="2444673319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1907726193"/>
                    </a:ext>
                  </a:extLst>
                </a:gridCol>
                <a:gridCol w="605027">
                  <a:extLst>
                    <a:ext uri="{9D8B030D-6E8A-4147-A177-3AD203B41FA5}">
                      <a16:colId xmlns:a16="http://schemas.microsoft.com/office/drawing/2014/main" val="3334150360"/>
                    </a:ext>
                  </a:extLst>
                </a:gridCol>
              </a:tblGrid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ja-JP" alt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　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Weight D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93165097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2780101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2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9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61851490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67978496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42411665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6305396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2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4178621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9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7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8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05345613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5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4.0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2741368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8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4381680"/>
                  </a:ext>
                </a:extLst>
              </a:tr>
              <a:tr h="14790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N10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6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5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4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3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1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1.9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48016364"/>
                  </a:ext>
                </a:extLst>
              </a:tr>
              <a:tr h="27874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Mean±SD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93±0.69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74±0.66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66±0.6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54±0.7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4±0.6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3±0.65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18±0.61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3.04±0.64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9±0.63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85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游ゴシック" panose="020B0400000000000000" pitchFamily="50" charset="-128"/>
                        </a:rPr>
                        <a:t>22.78±0.68</a:t>
                      </a:r>
                    </a:p>
                  </a:txBody>
                  <a:tcPr marL="5689" marR="5689" marT="5689" marB="0" anchor="ctr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42530975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1422016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6580</TotalTime>
  <Words>2441</Words>
  <Application>Microsoft Office PowerPoint</Application>
  <PresentationFormat>A4 Paper (210x297 mm)</PresentationFormat>
  <Paragraphs>892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2" baseType="lpstr">
      <vt:lpstr>游明朝</vt:lpstr>
      <vt:lpstr>Arial</vt:lpstr>
      <vt:lpstr>Calibri</vt:lpstr>
      <vt:lpstr>Times New Roman</vt:lpstr>
      <vt:lpstr>Office ​​テーマ</vt:lpstr>
      <vt:lpstr>Targeting the Undruggable Transcription Factor, KLF5, with a Peptidomimetic Small Molecule, NC114, Attenuates Pressure Overload-Induced Cardiac Remodeling and Fibrosis  Thanachai Methatham1, Natsuka Kimura1, Shota Tomida1, Tamaki Ishima1, Yuki Taguchi1,2, Hideki Uosaki2, Eiji Sakashita2, Hitoshi Endo2, Ryozo Nagai3,* &amp; Kenichi Aizawa1,4,*   1 Department of Translational Research, Clinical Research Center, Jichi Medical University Hospital, Tochigi, 329-0498, Japan 2 Division of Functional Biochemistry, Department of Biochemistry, Jichi Medical University, Tochigi, 329-0498, Japan 3 Jichi Medical University, Tochigi, 329-0498, Japan 4 Clinical Pharmacology Center, Jichi Medical University Hospital, Tochigi, 329-0498, Japan   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臨薬</dc:creator>
  <cp:lastModifiedBy>Bestbebase Basebebest</cp:lastModifiedBy>
  <cp:revision>402</cp:revision>
  <cp:lastPrinted>2025-12-02T02:16:44Z</cp:lastPrinted>
  <dcterms:created xsi:type="dcterms:W3CDTF">2020-09-08T01:29:43Z</dcterms:created>
  <dcterms:modified xsi:type="dcterms:W3CDTF">2025-12-11T18:03:17Z</dcterms:modified>
</cp:coreProperties>
</file>